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FCC874F-811F-461E-AF72-AED88905885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B4A24D7-8B98-4284-A653-2FF4A1D9C15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612DE1D-0344-4B46-B5FB-A09E5D8AC36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1BB9353-2B4D-4A86-8C93-96547B30C7D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FCE7BD2-63C6-4389-9BE5-28E9D662780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5E8D795-9688-4A53-B1EF-2F406A3FB98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D65F1B3-597F-4DDC-968C-6B2DE74BA43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3C7B1EA-D801-4315-A48A-650F532F0C0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BCC3C15-DD8F-4EEC-A3BF-EBB0BB13E4D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D469906-6609-43DA-8934-BFC5B256E0C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296EB03-DA65-4C8D-99FB-08D1B2E3E05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8CC61B2-E343-4F04-9107-7FA956F7D30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70205A9-E27D-4539-B80D-96A48598316F}"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 Box 11"/>
          <p:cNvSpPr/>
          <p:nvPr/>
        </p:nvSpPr>
        <p:spPr>
          <a:xfrm>
            <a:off x="833400" y="3473280"/>
            <a:ext cx="7284960" cy="2838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Verdana"/>
                <a:ea typeface="Verdana"/>
              </a:rPr>
              <a:t>S4 Fig.  GUS staining in PAP1wgΔInt1:GUS and PAP1wgΔInts:GUS lines</a:t>
            </a:r>
            <a:r>
              <a:rPr b="0" lang="en-US" sz="2000" spc="-1" strike="noStrike">
                <a:solidFill>
                  <a:srgbClr val="000000"/>
                </a:solidFill>
                <a:latin typeface="Verdana"/>
                <a:ea typeface="Verdana"/>
              </a:rPr>
              <a:t>. Gus staining in PAP1wgΔInt1:GUS and PAP1wgΔInts:GUS lines was observed along the major vein of rosette leaves (A) with greater intensity towards the petiole and at the base of the rosette (B).  Staining was also observed  at a discrete spot at the base of cauline leaves (C).  No other staining was observed in these lines.</a:t>
            </a:r>
            <a:endParaRPr b="0" lang="en-US" sz="2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p:txBody>
      </p:sp>
      <p:grpSp>
        <p:nvGrpSpPr>
          <p:cNvPr id="42" name="Group 13"/>
          <p:cNvGrpSpPr/>
          <p:nvPr/>
        </p:nvGrpSpPr>
        <p:grpSpPr>
          <a:xfrm>
            <a:off x="687240" y="1211400"/>
            <a:ext cx="7493040" cy="1953720"/>
            <a:chOff x="687240" y="1211400"/>
            <a:chExt cx="7493040" cy="1953720"/>
          </a:xfrm>
        </p:grpSpPr>
        <p:pic>
          <p:nvPicPr>
            <p:cNvPr id="43" name="Picture 8" descr="int12 4A 8X cauline1mod"/>
            <p:cNvPicPr/>
            <p:nvPr/>
          </p:nvPicPr>
          <p:blipFill>
            <a:blip r:embed="rId1"/>
            <a:stretch/>
          </p:blipFill>
          <p:spPr>
            <a:xfrm>
              <a:off x="5748480" y="1220760"/>
              <a:ext cx="2431800" cy="1944360"/>
            </a:xfrm>
            <a:prstGeom prst="rect">
              <a:avLst/>
            </a:prstGeom>
            <a:ln w="0">
              <a:noFill/>
            </a:ln>
          </p:spPr>
        </p:pic>
        <p:pic>
          <p:nvPicPr>
            <p:cNvPr id="44" name="Picture 9" descr="int1 2C 6"/>
            <p:cNvPicPr/>
            <p:nvPr/>
          </p:nvPicPr>
          <p:blipFill>
            <a:blip r:embed="rId2"/>
            <a:stretch/>
          </p:blipFill>
          <p:spPr>
            <a:xfrm>
              <a:off x="687240" y="1220760"/>
              <a:ext cx="2432160" cy="1944360"/>
            </a:xfrm>
            <a:prstGeom prst="rect">
              <a:avLst/>
            </a:prstGeom>
            <a:ln w="0">
              <a:noFill/>
            </a:ln>
          </p:spPr>
        </p:pic>
        <p:pic>
          <p:nvPicPr>
            <p:cNvPr id="45" name="Picture 10" descr="int12 4A 6"/>
            <p:cNvPicPr/>
            <p:nvPr/>
          </p:nvPicPr>
          <p:blipFill>
            <a:blip r:embed="rId3"/>
            <a:stretch/>
          </p:blipFill>
          <p:spPr>
            <a:xfrm>
              <a:off x="3217680" y="1220760"/>
              <a:ext cx="2432160" cy="1944360"/>
            </a:xfrm>
            <a:prstGeom prst="rect">
              <a:avLst/>
            </a:prstGeom>
            <a:ln w="0">
              <a:noFill/>
            </a:ln>
          </p:spPr>
        </p:pic>
        <p:sp>
          <p:nvSpPr>
            <p:cNvPr id="46" name="Text Box 4"/>
            <p:cNvSpPr/>
            <p:nvPr/>
          </p:nvSpPr>
          <p:spPr>
            <a:xfrm>
              <a:off x="728640" y="121140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Arial"/>
                </a:rPr>
                <a:t>A</a:t>
              </a:r>
              <a:endParaRPr b="0" lang="en-US" sz="1800" spc="-1" strike="noStrike">
                <a:solidFill>
                  <a:srgbClr val="000000"/>
                </a:solidFill>
                <a:latin typeface="Arial"/>
              </a:endParaRPr>
            </a:p>
          </p:txBody>
        </p:sp>
        <p:sp>
          <p:nvSpPr>
            <p:cNvPr id="47" name="Text Box 5"/>
            <p:cNvSpPr/>
            <p:nvPr/>
          </p:nvSpPr>
          <p:spPr>
            <a:xfrm>
              <a:off x="3254400" y="121140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Arial"/>
                </a:rPr>
                <a:t>B</a:t>
              </a:r>
              <a:endParaRPr b="0" lang="en-US" sz="1800" spc="-1" strike="noStrike">
                <a:solidFill>
                  <a:srgbClr val="000000"/>
                </a:solidFill>
                <a:latin typeface="Arial"/>
              </a:endParaRPr>
            </a:p>
          </p:txBody>
        </p:sp>
        <p:sp>
          <p:nvSpPr>
            <p:cNvPr id="48" name="Text Box 6"/>
            <p:cNvSpPr/>
            <p:nvPr/>
          </p:nvSpPr>
          <p:spPr>
            <a:xfrm>
              <a:off x="5926320" y="12114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Arial"/>
                </a:rPr>
                <a:t>C</a:t>
              </a:r>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6-26T14:34:27Z</dcterms:created>
  <dc:creator>bettina</dc:creator>
  <dc:description/>
  <dc:language>en-US</dc:language>
  <cp:lastModifiedBy>Bettina</cp:lastModifiedBy>
  <dcterms:modified xsi:type="dcterms:W3CDTF">2016-01-08T16:58:32Z</dcterms:modified>
  <cp:revision>11</cp:revision>
  <dc:subject/>
  <dc:title>Slide 1</dc:title>
</cp:coreProperties>
</file>